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7D08B-7C17-41EC-9496-ED72023D57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833B60-8DDD-48F3-A225-13840E6FEB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4F7D1-04B2-4DA4-8B30-A5233CCF3E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8C3FB-A708-4681-913A-A7EAAE390B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84572-3C65-4DD1-8CDA-A467535F8B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0611F-CEBC-490B-A80F-2E64BC4A03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5B501-6D38-456A-9370-7B122714DA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56F32-950E-44BA-B1B8-90205DB245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9B8F6-86F7-4A1D-82AB-44FC512C4C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E7148-317E-421B-82F5-D4F2CAB4D3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A4ECA-FECF-454A-BD2F-E226183C81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6E9C16-CE63-43CD-8EAA-58349B362B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37FAD6-2201-4BE7-BF04-860941ECEFAB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364320" y="2071800"/>
            <a:ext cx="104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Figure E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Object 7" descr=""/>
          <p:cNvPicPr/>
          <p:nvPr/>
        </p:nvPicPr>
        <p:blipFill>
          <a:blip r:embed="rId1"/>
          <a:stretch/>
        </p:blipFill>
        <p:spPr>
          <a:xfrm>
            <a:off x="476280" y="2505240"/>
            <a:ext cx="6592680" cy="4316400"/>
          </a:xfrm>
          <a:prstGeom prst="rect">
            <a:avLst/>
          </a:prstGeom>
          <a:ln w="0">
            <a:noFill/>
          </a:ln>
        </p:spPr>
      </p:pic>
      <p:sp>
        <p:nvSpPr>
          <p:cNvPr id="43" name="TextBox 1"/>
          <p:cNvSpPr/>
          <p:nvPr/>
        </p:nvSpPr>
        <p:spPr>
          <a:xfrm>
            <a:off x="333360" y="488880"/>
            <a:ext cx="6120000" cy="158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Gammaherpesvirus infection modulates the temporal and spatial expression of SCGB1A1(CCSP) and BPIFA1 (SPLUNC1) in the respiratory trac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Gail H. Leeming, Anja Kipar, David J. Hughes, Lynne Bingle, Elaine Bennett, Nathifa Moyo, Ralph A. Tripp, Alison Bigley, Colin D. Bingle, Jeffery T. Sample, James P. Stewar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TextBox 3" descr=""/>
          <p:cNvPicPr/>
          <p:nvPr/>
        </p:nvPicPr>
        <p:blipFill>
          <a:blip r:embed="rId2"/>
          <a:stretch/>
        </p:blipFill>
        <p:spPr>
          <a:xfrm>
            <a:off x="255600" y="7034040"/>
            <a:ext cx="6346800" cy="264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"/>
          <p:cNvSpPr/>
          <p:nvPr/>
        </p:nvSpPr>
        <p:spPr>
          <a:xfrm>
            <a:off x="479880" y="415800"/>
            <a:ext cx="104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Figure E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Object 9" descr=""/>
          <p:cNvPicPr/>
          <p:nvPr/>
        </p:nvPicPr>
        <p:blipFill>
          <a:blip r:embed="rId1"/>
          <a:stretch/>
        </p:blipFill>
        <p:spPr>
          <a:xfrm>
            <a:off x="404640" y="1216080"/>
            <a:ext cx="6605640" cy="776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1"/>
          <p:cNvSpPr/>
          <p:nvPr/>
        </p:nvSpPr>
        <p:spPr>
          <a:xfrm>
            <a:off x="355680" y="486000"/>
            <a:ext cx="6048360" cy="423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E2: Alignment of BPIFA1 amino-acid sequenc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The amino-acid sequence of BPIFA1 from wood mouse was compared with equivalent sequences from a number of mammalian species using BLAST,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d ClustalW2.0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d the Clustal output was represented diagrammatically using and Boxshade3.21 (www.ch.EMBnet.org). White text on dark grey represents residues conserved between species and white text on mid-grey represents residues that are semi-conserved. The BPIFA1 sequences used for analysis are conceptual translations from the mRNA sequences held in Genbank as follows:  Wood mouse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podemus sylvaticu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) HM008620, House mouse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us musculu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) NM_011126.3, Rat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Rattus norvegicu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) NM_172031.1, Hamster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ricetulus griseu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)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XM_003512019.1,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Chinchilla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hinchilla lanigera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J830605.1, Cow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Bos Tauru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) BC114803.1, Human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Homo sapien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) NM_016583.3. The Kangaroo rat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Dipodomys ordii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)  sequence was from a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Ensembl gene prediction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ENSDORP0000000213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REFERENC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ltschul SF, Madden TL, Schaffer AA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, 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Gapped BLAST and PSI-BLAST: a new generation of protein database search programs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Nucleic Acids Re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1997;25(17):3389-3402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Larkin MA, Blackshields G, Brown NP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, 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Clustal W and Clustal X version 2.0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Bioinformatic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2007;23(21):2947-2948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21T08:44:11Z</dcterms:created>
  <dc:creator>James</dc:creator>
  <dc:description/>
  <dc:language>en-US</dc:language>
  <cp:lastModifiedBy>ravikumar.n</cp:lastModifiedBy>
  <dcterms:modified xsi:type="dcterms:W3CDTF">2014-12-17T09:15:22Z</dcterms:modified>
  <cp:revision>13</cp:revision>
  <dc:subject/>
  <dc:title>Slide 1</dc:title>
</cp:coreProperties>
</file>